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wmf" ContentType="image/x-wmf"/>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BA397DBE-E680-4218-8CFE-68C805A698DA}"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0F64048F-375D-46CC-A366-646F80D3BD1C}"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8FFCC920-5C55-4801-9B95-B27648C2EAAA}"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BE80A80E-45E0-418B-82CD-AFBB8660987B}"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rtl="1">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D1942F32-D01C-4774-9D8D-F6DF484A525E}"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B134590E-11F4-4897-9AFF-AC02FA6CDF65}"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215AB59D-CB7A-4879-BAB4-FA055C4D77A0}"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630F2EE-EAAE-49A5-9759-4F12381CBBA0}"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rtl="1">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3E0218A-2EB4-41C8-9DEE-CEC57C79235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15BC78A-7B7B-44FC-B442-92A950E86410}"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74F76DA-683A-4A41-B11F-22AEF9372056}"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lgn="r" rtl="1">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2D04E38-9ED7-4EC5-A8D6-3BC6D40628A3}"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lgn="r" rtl="1">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lgn="r" rtl="1">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lgn="r" rtl="1">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lgn="r" rtl="1">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lgn="r" rtl="1">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lgn="r" rtl="1">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lgn="r" rtl="1">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6552720" y="6244920"/>
            <a:ext cx="2133720" cy="476280"/>
          </a:xfrm>
          <a:prstGeom prst="rect">
            <a:avLst/>
          </a:prstGeom>
          <a:noFill/>
          <a:ln w="0">
            <a:noFill/>
          </a:ln>
        </p:spPr>
        <p:txBody>
          <a:bodyPr lIns="90000" rIns="90000" tIns="46800" bIns="46800" anchor="t">
            <a:noAutofit/>
          </a:bodyPr>
          <a:p>
            <a:pPr indent="0" algn="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p>
            <a:pPr indent="0" algn="r"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456840" y="6244920"/>
            <a:ext cx="2133720" cy="476280"/>
          </a:xfrm>
          <a:prstGeom prst="rect">
            <a:avLst/>
          </a:prstGeom>
          <a:noFill/>
          <a:ln w="0">
            <a:noFill/>
          </a:ln>
        </p:spPr>
        <p:txBody>
          <a:bodyPr lIns="90000" rIns="90000" tIns="46800" bIns="46800" anchor="t">
            <a:noAutofit/>
          </a:bodyPr>
          <a:lstStyle>
            <a:lvl1pPr indent="0"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he-IL" sz="1400" spc="-1" strike="noStrike">
                <a:solidFill>
                  <a:srgbClr val="000000"/>
                </a:solidFill>
                <a:latin typeface="Arial"/>
              </a:defRPr>
            </a:lvl1pPr>
          </a:lstStyle>
          <a:p>
            <a:pPr indent="0" rtl="1">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C602F8C3-7696-48A5-9024-87521843E283}" type="slidenum">
              <a:rPr b="0" lang="he-IL"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wmf"/><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1" name="Picture 5" descr=""/>
          <p:cNvPicPr/>
          <p:nvPr/>
        </p:nvPicPr>
        <p:blipFill>
          <a:blip r:embed="rId1"/>
          <a:stretch/>
        </p:blipFill>
        <p:spPr>
          <a:xfrm>
            <a:off x="395280" y="0"/>
            <a:ext cx="5256360" cy="4130640"/>
          </a:xfrm>
          <a:prstGeom prst="rect">
            <a:avLst/>
          </a:prstGeom>
          <a:ln w="0">
            <a:noFill/>
          </a:ln>
        </p:spPr>
      </p:pic>
      <p:sp>
        <p:nvSpPr>
          <p:cNvPr id="42" name="Text Box 6"/>
          <p:cNvSpPr/>
          <p:nvPr/>
        </p:nvSpPr>
        <p:spPr>
          <a:xfrm>
            <a:off x="1647720" y="4106880"/>
            <a:ext cx="3600720" cy="173664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ea typeface="Times New Roman"/>
              </a:rPr>
              <a:t>Figure S4: Time-dependent refolding of denatured MDH by GroEL and Pf-cpn20. </a:t>
            </a:r>
            <a:r>
              <a:rPr b="0" lang="en-US" sz="1200" spc="-1" strike="noStrike">
                <a:solidFill>
                  <a:srgbClr val="000000"/>
                </a:solidFill>
                <a:latin typeface="Times New Roman"/>
                <a:ea typeface="Times New Roman"/>
              </a:rPr>
              <a:t>Urea-denatured malate dehydrogenase was refolded by GroEL (10 µM) with the help of 20 µM Pf-cpn20, At-cpn20 or GroES.  The refolding reaction was carried out as described in Materials and Methods.  Refolding yields are expressed as the activity obtained relative to the highest value obtained with GroES. Values represent the average of 4 independent experiments +/- standard deviation.</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6</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2-11-22T09:05:34Z</dcterms:created>
  <dc:creator>AzemA3</dc:creator>
  <dc:description/>
  <dc:language>en-US</dc:language>
  <cp:lastModifiedBy>selest</cp:lastModifiedBy>
  <dcterms:modified xsi:type="dcterms:W3CDTF">2012-11-22T19:37:27Z</dcterms:modified>
  <cp:revision>4</cp:revision>
  <dc:subject/>
  <dc:title>Slide 1</dc:title>
</cp:coreProperties>
</file>